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63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04E2FE-DC08-4DD0-9986-F519A5BA77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F96FAE7-6650-4372-AA0F-B36C12975F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893354-447B-451F-9B07-E99DE5A21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F6FC1B-99A9-4BB8-9385-E92557DBA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4CDC98-A501-4DC5-893B-050DA1CFE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80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9C4155-EAC7-47E1-8F97-7CB527E209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8A34D8B-14E9-47BB-B73C-EA29D23FEE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2ACDE8-5CC6-4281-A380-81C2358B3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DC8474-9F61-4F44-801C-3BFBC38BB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526764-5283-43DA-8849-83BCF9FC8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8543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889D23D-5ACC-4BBB-8DFF-552527F04C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FDD893B-1267-43D1-9120-FD1BCBAFA1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A77368-A56D-4D8D-A6A3-AD1F6ECC3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759FF2-C1E1-43F5-8F72-B3C83B900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85B9C4-8D13-4005-9DCF-8CF8726C6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91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F7A40F-9973-432E-9E9D-244AACF8A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90780C-E2CB-4419-9009-82F3DDBB95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D2E938-3BB5-4BBC-8987-78E13C012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49D3E5-65B5-4E23-9BB1-A708B373F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31C25F-9DE8-472A-8AEF-7EEF605C7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9785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570F91-B454-4D13-80A6-C47C6FD91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0861D2A-5A57-4232-8C4C-52E4C1EB97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0AEE2F-5E13-4385-93B3-C620C7774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976841-EC6B-4F18-8BF6-2367E5822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7DF8BA-431D-4BB2-9126-8A19B2EA0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982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A3EAE8-1EB3-4912-92DF-F1B46D665E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FECECBA-9092-4818-80C3-E70987286F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5FD5EE2-53F9-48C2-AF3A-FC623F6151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7845C6-E786-45AD-9CFA-64A0E114C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D1606A-A705-4433-BC36-4A8382D89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854957-56D7-4450-B5FA-DEC86A205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9211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73E8AB-5BE5-4478-8A24-50937961E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B52E65-F251-4AAF-8713-EAF6EBE2C5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9223D8-C987-47E7-A555-C7595B75B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8BDD791-E5EC-4EBC-BE87-04F32B9DB1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1CE479F-30A4-4C45-96A2-19A7B6034A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21B73D4-FA79-4340-81B2-F3F10B1F4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9DF264E-F615-4F1F-89C4-B35A60E69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AAE4FCA-BEFB-4188-B58F-048189ABF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2644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62CCE7-3F67-4260-9EE9-D98CA4444C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C2DABB1-8B6A-4CB2-91F1-1112408F7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E79E54-9955-4A53-8EF6-FA60B7854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9A726D6-9E21-47B7-AF89-15620A9D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51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B4C02B7-0B30-4096-A5A1-3C20E5870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B1660AC-8F84-4A24-90F9-13AB0794C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003F3EF-958B-4200-9C2D-6A3E5662F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5373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35AC6C-61AF-4CA0-8D87-95AF9D436E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12C624-E74D-4FF9-9647-8939ABF7D1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380608-B652-4ACC-952B-D9A72D98D3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11C3468-2E4B-4F17-9051-1504E1CC8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9BD6731-1406-4095-925C-B859E5DE9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BFF799-419A-4656-A2DC-2FEE33BD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36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ACDC30-61AD-4CF7-AA25-1AEE0F5A47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8DA6F5C-0F0A-40AB-9BF8-1EB9457787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54E6BA-650C-48F8-A9DA-C9E058F7F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013835-5A49-4180-B432-5EEBA8310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32C9B5C-2003-42A5-A200-80028F757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2E1233-42B8-49D1-89FE-A67764AEA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330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A2BA504-ADC8-4230-8283-48707BA255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B152D7-F246-49EF-A280-62B19C9FFA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B2DD09-C7F4-499E-8C61-8F32B4DAF2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D6274-DA64-480C-9619-DBE11407928A}" type="datetimeFigureOut">
              <a:rPr kumimoji="1" lang="ja-JP" altLang="en-US" smtClean="0"/>
              <a:t>2026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20AA10-6FF9-409E-B023-9C99F7112E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A949D9-8C68-4B7E-9EB0-005B87ED3C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EC92A-348E-4B6B-BE52-F04FBA912D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8690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92106A22-7B2B-4ED2-AFDC-0C0F7007A791}"/>
              </a:ext>
            </a:extLst>
          </p:cNvPr>
          <p:cNvGrpSpPr/>
          <p:nvPr/>
        </p:nvGrpSpPr>
        <p:grpSpPr>
          <a:xfrm>
            <a:off x="2233707" y="629454"/>
            <a:ext cx="7402513" cy="5168478"/>
            <a:chOff x="2260601" y="677863"/>
            <a:chExt cx="7402513" cy="5168478"/>
          </a:xfrm>
        </p:grpSpPr>
        <p:grpSp>
          <p:nvGrpSpPr>
            <p:cNvPr id="100" name="グループ化 99">
              <a:extLst>
                <a:ext uri="{FF2B5EF4-FFF2-40B4-BE49-F238E27FC236}">
                  <a16:creationId xmlns:a16="http://schemas.microsoft.com/office/drawing/2014/main" id="{40A42A16-0040-4771-A563-B9724093CEF9}"/>
                </a:ext>
              </a:extLst>
            </p:cNvPr>
            <p:cNvGrpSpPr/>
            <p:nvPr/>
          </p:nvGrpSpPr>
          <p:grpSpPr>
            <a:xfrm>
              <a:off x="2260601" y="677863"/>
              <a:ext cx="7402513" cy="5168478"/>
              <a:chOff x="2260601" y="677863"/>
              <a:chExt cx="7402513" cy="5168478"/>
            </a:xfrm>
          </p:grpSpPr>
          <p:sp>
            <p:nvSpPr>
              <p:cNvPr id="10" name="Line 7">
                <a:extLst>
                  <a:ext uri="{FF2B5EF4-FFF2-40B4-BE49-F238E27FC236}">
                    <a16:creationId xmlns:a16="http://schemas.microsoft.com/office/drawing/2014/main" id="{E545FB6B-E0FD-4467-B9CA-D4FD9CDA88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738" y="5010150"/>
                <a:ext cx="104775" cy="0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" name="Line 8">
                <a:extLst>
                  <a:ext uri="{FF2B5EF4-FFF2-40B4-BE49-F238E27FC236}">
                    <a16:creationId xmlns:a16="http://schemas.microsoft.com/office/drawing/2014/main" id="{B91B6C92-FFD6-4555-A45F-729C45A0DE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738" y="4175125"/>
                <a:ext cx="104775" cy="0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" name="Line 9">
                <a:extLst>
                  <a:ext uri="{FF2B5EF4-FFF2-40B4-BE49-F238E27FC236}">
                    <a16:creationId xmlns:a16="http://schemas.microsoft.com/office/drawing/2014/main" id="{14FA29EA-56DE-47A6-9F01-1B80FF3DC9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738" y="3340100"/>
                <a:ext cx="104775" cy="0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" name="Line 10">
                <a:extLst>
                  <a:ext uri="{FF2B5EF4-FFF2-40B4-BE49-F238E27FC236}">
                    <a16:creationId xmlns:a16="http://schemas.microsoft.com/office/drawing/2014/main" id="{614ACDA8-1EC8-4956-AA38-1691EE0797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738" y="2505075"/>
                <a:ext cx="104775" cy="0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" name="Line 11">
                <a:extLst>
                  <a:ext uri="{FF2B5EF4-FFF2-40B4-BE49-F238E27FC236}">
                    <a16:creationId xmlns:a16="http://schemas.microsoft.com/office/drawing/2014/main" id="{26BF8B8B-0556-4059-A2DF-60ED568BA1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738" y="1670050"/>
                <a:ext cx="104775" cy="0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" name="Line 12">
                <a:extLst>
                  <a:ext uri="{FF2B5EF4-FFF2-40B4-BE49-F238E27FC236}">
                    <a16:creationId xmlns:a16="http://schemas.microsoft.com/office/drawing/2014/main" id="{5C0490B1-20B6-45B8-9F39-B428C278B0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738" y="835025"/>
                <a:ext cx="104775" cy="0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" name="Rectangle 13">
                <a:extLst>
                  <a:ext uri="{FF2B5EF4-FFF2-40B4-BE49-F238E27FC236}">
                    <a16:creationId xmlns:a16="http://schemas.microsoft.com/office/drawing/2014/main" id="{FB9FAF62-7551-4947-A873-1A397C24CE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1701" y="4852988"/>
                <a:ext cx="3127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Rectangle 14">
                <a:extLst>
                  <a:ext uri="{FF2B5EF4-FFF2-40B4-BE49-F238E27FC236}">
                    <a16:creationId xmlns:a16="http://schemas.microsoft.com/office/drawing/2014/main" id="{2B17F0F3-0A0E-4D06-900B-53D9CF55E5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4338" y="4017963"/>
                <a:ext cx="8334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20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Rectangle 15">
                <a:extLst>
                  <a:ext uri="{FF2B5EF4-FFF2-40B4-BE49-F238E27FC236}">
                    <a16:creationId xmlns:a16="http://schemas.microsoft.com/office/drawing/2014/main" id="{AC7579D9-5275-40B7-A74D-53A9948E20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4338" y="3182938"/>
                <a:ext cx="8334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40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Rectangle 16">
                <a:extLst>
                  <a:ext uri="{FF2B5EF4-FFF2-40B4-BE49-F238E27FC236}">
                    <a16:creationId xmlns:a16="http://schemas.microsoft.com/office/drawing/2014/main" id="{6C39CA62-E93C-45D9-AD29-B26FC4D124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4338" y="2347913"/>
                <a:ext cx="8334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60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Rectangle 17">
                <a:extLst>
                  <a:ext uri="{FF2B5EF4-FFF2-40B4-BE49-F238E27FC236}">
                    <a16:creationId xmlns:a16="http://schemas.microsoft.com/office/drawing/2014/main" id="{8D979932-26F0-4E58-81CE-DF43F66B07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4338" y="1512888"/>
                <a:ext cx="8334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80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" name="Rectangle 18">
                <a:extLst>
                  <a:ext uri="{FF2B5EF4-FFF2-40B4-BE49-F238E27FC236}">
                    <a16:creationId xmlns:a16="http://schemas.microsoft.com/office/drawing/2014/main" id="{A8460539-ACC9-47A8-9D5A-3BAD4055AF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3688" y="677863"/>
                <a:ext cx="9731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00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" name="Rectangle 19">
                <a:extLst>
                  <a:ext uri="{FF2B5EF4-FFF2-40B4-BE49-F238E27FC236}">
                    <a16:creationId xmlns:a16="http://schemas.microsoft.com/office/drawing/2014/main" id="{80A8C7B0-A6DA-4162-B306-88D0809AE1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0601" y="2747963"/>
                <a:ext cx="590550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LCR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" name="Rectangle 20">
                <a:extLst>
                  <a:ext uri="{FF2B5EF4-FFF2-40B4-BE49-F238E27FC236}">
                    <a16:creationId xmlns:a16="http://schemas.microsoft.com/office/drawing/2014/main" id="{44D91C20-3D68-445C-BDAA-14EF46801C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1576" y="827088"/>
                <a:ext cx="5561013" cy="41751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" name="Oval 21">
                <a:extLst>
                  <a:ext uri="{FF2B5EF4-FFF2-40B4-BE49-F238E27FC236}">
                    <a16:creationId xmlns:a16="http://schemas.microsoft.com/office/drawing/2014/main" id="{C4BB8FD5-23F3-46B9-8249-F3C5236B46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1576" y="4924425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" name="Oval 22">
                <a:extLst>
                  <a:ext uri="{FF2B5EF4-FFF2-40B4-BE49-F238E27FC236}">
                    <a16:creationId xmlns:a16="http://schemas.microsoft.com/office/drawing/2014/main" id="{7801C42E-695F-4011-88F2-9E0D51A4C2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6201" y="4351338"/>
                <a:ext cx="90488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" name="Oval 23">
                <a:extLst>
                  <a:ext uri="{FF2B5EF4-FFF2-40B4-BE49-F238E27FC236}">
                    <a16:creationId xmlns:a16="http://schemas.microsoft.com/office/drawing/2014/main" id="{38185DAA-2FB8-44C5-8663-B1A561EF8E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0176" y="434340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" name="Oval 24">
                <a:extLst>
                  <a:ext uri="{FF2B5EF4-FFF2-40B4-BE49-F238E27FC236}">
                    <a16:creationId xmlns:a16="http://schemas.microsoft.com/office/drawing/2014/main" id="{552EC19A-0665-4A6A-BE6B-AC674D7D3B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9701" y="3862388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" name="Oval 25">
                <a:extLst>
                  <a:ext uri="{FF2B5EF4-FFF2-40B4-BE49-F238E27FC236}">
                    <a16:creationId xmlns:a16="http://schemas.microsoft.com/office/drawing/2014/main" id="{35D74BC5-998D-4775-A293-3139F0DBD7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32251" y="4932363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" name="Oval 26">
                <a:extLst>
                  <a:ext uri="{FF2B5EF4-FFF2-40B4-BE49-F238E27FC236}">
                    <a16:creationId xmlns:a16="http://schemas.microsoft.com/office/drawing/2014/main" id="{C635B83B-498D-4D40-8219-F7EB9103C1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68763" y="4821238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" name="Oval 27">
                <a:extLst>
                  <a:ext uri="{FF2B5EF4-FFF2-40B4-BE49-F238E27FC236}">
                    <a16:creationId xmlns:a16="http://schemas.microsoft.com/office/drawing/2014/main" id="{D3CD2ED7-DADE-4D49-A067-157A81E520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68763" y="4640263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" name="Oval 28">
                <a:extLst>
                  <a:ext uri="{FF2B5EF4-FFF2-40B4-BE49-F238E27FC236}">
                    <a16:creationId xmlns:a16="http://schemas.microsoft.com/office/drawing/2014/main" id="{3DFB37DF-0C84-4D79-BF36-AC9B2FF1C8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4813" y="4900613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" name="Oval 29">
                <a:extLst>
                  <a:ext uri="{FF2B5EF4-FFF2-40B4-BE49-F238E27FC236}">
                    <a16:creationId xmlns:a16="http://schemas.microsoft.com/office/drawing/2014/main" id="{E784A260-A343-44B2-B94F-5F4C57B54E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24351" y="2824163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" name="Oval 30">
                <a:extLst>
                  <a:ext uri="{FF2B5EF4-FFF2-40B4-BE49-F238E27FC236}">
                    <a16:creationId xmlns:a16="http://schemas.microsoft.com/office/drawing/2014/main" id="{EDF41846-CE9B-44D2-AB9E-651FAEED07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51338" y="4668838"/>
                <a:ext cx="93663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" name="Oval 31">
                <a:extLst>
                  <a:ext uri="{FF2B5EF4-FFF2-40B4-BE49-F238E27FC236}">
                    <a16:creationId xmlns:a16="http://schemas.microsoft.com/office/drawing/2014/main" id="{5C8A4A8C-F647-4D8E-9159-93836C98CE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4526" y="4706938"/>
                <a:ext cx="93663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" name="Oval 32">
                <a:extLst>
                  <a:ext uri="{FF2B5EF4-FFF2-40B4-BE49-F238E27FC236}">
                    <a16:creationId xmlns:a16="http://schemas.microsoft.com/office/drawing/2014/main" id="{4C3143BD-A0FD-46A8-8576-A314ACAD29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9451" y="4927600"/>
                <a:ext cx="92075" cy="93662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" name="Oval 33">
                <a:extLst>
                  <a:ext uri="{FF2B5EF4-FFF2-40B4-BE49-F238E27FC236}">
                    <a16:creationId xmlns:a16="http://schemas.microsoft.com/office/drawing/2014/main" id="{AE47EA7D-7432-4E19-AF50-A5483E971F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9451" y="4803775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" name="Oval 34">
                <a:extLst>
                  <a:ext uri="{FF2B5EF4-FFF2-40B4-BE49-F238E27FC236}">
                    <a16:creationId xmlns:a16="http://schemas.microsoft.com/office/drawing/2014/main" id="{8ECE18CB-FE08-4D72-8DBE-2A7452A1A1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9451" y="4575175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" name="Oval 35">
                <a:extLst>
                  <a:ext uri="{FF2B5EF4-FFF2-40B4-BE49-F238E27FC236}">
                    <a16:creationId xmlns:a16="http://schemas.microsoft.com/office/drawing/2014/main" id="{8BF23997-8DD1-42E0-8778-E9808BC34E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1526" y="2357438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" name="Oval 36">
                <a:extLst>
                  <a:ext uri="{FF2B5EF4-FFF2-40B4-BE49-F238E27FC236}">
                    <a16:creationId xmlns:a16="http://schemas.microsoft.com/office/drawing/2014/main" id="{A79896AE-7477-4CDA-BAA1-897E0C3089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5976" y="4140200"/>
                <a:ext cx="93663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" name="Oval 37">
                <a:extLst>
                  <a:ext uri="{FF2B5EF4-FFF2-40B4-BE49-F238E27FC236}">
                    <a16:creationId xmlns:a16="http://schemas.microsoft.com/office/drawing/2014/main" id="{9D886DAB-F5BC-4182-9344-2E7CAFDEBE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3601" y="4897438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1" name="Oval 38">
                <a:extLst>
                  <a:ext uri="{FF2B5EF4-FFF2-40B4-BE49-F238E27FC236}">
                    <a16:creationId xmlns:a16="http://schemas.microsoft.com/office/drawing/2014/main" id="{F71303D4-33F2-4EB5-A750-6F2B7CD7D3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5826" y="83185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2" name="Oval 39">
                <a:extLst>
                  <a:ext uri="{FF2B5EF4-FFF2-40B4-BE49-F238E27FC236}">
                    <a16:creationId xmlns:a16="http://schemas.microsoft.com/office/drawing/2014/main" id="{550F77A4-0279-4430-8283-989862FC47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0126" y="485775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" name="Oval 40">
                <a:extLst>
                  <a:ext uri="{FF2B5EF4-FFF2-40B4-BE49-F238E27FC236}">
                    <a16:creationId xmlns:a16="http://schemas.microsoft.com/office/drawing/2014/main" id="{BC3D36BF-0032-45FE-ABBE-3DF9562CBD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0126" y="423545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" name="Oval 41">
                <a:extLst>
                  <a:ext uri="{FF2B5EF4-FFF2-40B4-BE49-F238E27FC236}">
                    <a16:creationId xmlns:a16="http://schemas.microsoft.com/office/drawing/2014/main" id="{CF39A33A-7393-4C03-A86A-CD714F3AF8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8726" y="4448175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" name="Oval 42">
                <a:extLst>
                  <a:ext uri="{FF2B5EF4-FFF2-40B4-BE49-F238E27FC236}">
                    <a16:creationId xmlns:a16="http://schemas.microsoft.com/office/drawing/2014/main" id="{30E6306D-91D6-4C35-BBC1-DE3F36F10B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538" y="1103313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" name="Oval 43">
                <a:extLst>
                  <a:ext uri="{FF2B5EF4-FFF2-40B4-BE49-F238E27FC236}">
                    <a16:creationId xmlns:a16="http://schemas.microsoft.com/office/drawing/2014/main" id="{BBB1DB07-F0F9-4B4E-B46D-22F61DBE80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4763" y="4340225"/>
                <a:ext cx="92075" cy="93662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" name="Oval 44">
                <a:extLst>
                  <a:ext uri="{FF2B5EF4-FFF2-40B4-BE49-F238E27FC236}">
                    <a16:creationId xmlns:a16="http://schemas.microsoft.com/office/drawing/2014/main" id="{FDC6A628-A18B-4378-A554-873C1B13D4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5401" y="4683125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" name="Oval 45">
                <a:extLst>
                  <a:ext uri="{FF2B5EF4-FFF2-40B4-BE49-F238E27FC236}">
                    <a16:creationId xmlns:a16="http://schemas.microsoft.com/office/drawing/2014/main" id="{5D757014-C76C-4B18-8311-FA072DCBED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0801" y="4240213"/>
                <a:ext cx="90488" cy="93662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" name="Oval 46">
                <a:extLst>
                  <a:ext uri="{FF2B5EF4-FFF2-40B4-BE49-F238E27FC236}">
                    <a16:creationId xmlns:a16="http://schemas.microsoft.com/office/drawing/2014/main" id="{24C34798-09FD-407E-B6AB-345AD5C5C2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18113" y="4481513"/>
                <a:ext cx="90488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" name="Oval 47">
                <a:extLst>
                  <a:ext uri="{FF2B5EF4-FFF2-40B4-BE49-F238E27FC236}">
                    <a16:creationId xmlns:a16="http://schemas.microsoft.com/office/drawing/2014/main" id="{5B14E559-D808-409F-9F81-6E699D2621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2563" y="4473575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" name="Oval 48">
                <a:extLst>
                  <a:ext uri="{FF2B5EF4-FFF2-40B4-BE49-F238E27FC236}">
                    <a16:creationId xmlns:a16="http://schemas.microsoft.com/office/drawing/2014/main" id="{68B13773-0E54-4782-9DB4-D2F8A90E86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7326" y="3913188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" name="Oval 49">
                <a:extLst>
                  <a:ext uri="{FF2B5EF4-FFF2-40B4-BE49-F238E27FC236}">
                    <a16:creationId xmlns:a16="http://schemas.microsoft.com/office/drawing/2014/main" id="{7B1D4978-ED3C-499D-8352-E37D2C3D75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8126" y="3490913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3" name="Oval 50">
                <a:extLst>
                  <a:ext uri="{FF2B5EF4-FFF2-40B4-BE49-F238E27FC236}">
                    <a16:creationId xmlns:a16="http://schemas.microsoft.com/office/drawing/2014/main" id="{42ABC6E7-5CAB-42A3-AFC6-35E6136949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7513" y="4845050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4" name="Oval 51">
                <a:extLst>
                  <a:ext uri="{FF2B5EF4-FFF2-40B4-BE49-F238E27FC236}">
                    <a16:creationId xmlns:a16="http://schemas.microsoft.com/office/drawing/2014/main" id="{51EDDCBB-1235-47A1-823A-D33A5985DA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7513" y="4737100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5" name="Oval 52">
                <a:extLst>
                  <a:ext uri="{FF2B5EF4-FFF2-40B4-BE49-F238E27FC236}">
                    <a16:creationId xmlns:a16="http://schemas.microsoft.com/office/drawing/2014/main" id="{CB2797BF-7978-46E6-BC8D-12B952A852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7513" y="4457700"/>
                <a:ext cx="90488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6" name="Oval 53">
                <a:extLst>
                  <a:ext uri="{FF2B5EF4-FFF2-40B4-BE49-F238E27FC236}">
                    <a16:creationId xmlns:a16="http://schemas.microsoft.com/office/drawing/2014/main" id="{6207455B-9AF5-41AC-B803-EF797AC1AC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7513" y="1476375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7" name="Oval 54">
                <a:extLst>
                  <a:ext uri="{FF2B5EF4-FFF2-40B4-BE49-F238E27FC236}">
                    <a16:creationId xmlns:a16="http://schemas.microsoft.com/office/drawing/2014/main" id="{400CBDB0-A6E8-47B1-9061-37460C29E3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6113" y="4889500"/>
                <a:ext cx="90488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8" name="Oval 55">
                <a:extLst>
                  <a:ext uri="{FF2B5EF4-FFF2-40B4-BE49-F238E27FC236}">
                    <a16:creationId xmlns:a16="http://schemas.microsoft.com/office/drawing/2014/main" id="{9395E9DD-ADA0-4192-910D-786F9A3E2A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6601" y="4916488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9" name="Oval 56">
                <a:extLst>
                  <a:ext uri="{FF2B5EF4-FFF2-40B4-BE49-F238E27FC236}">
                    <a16:creationId xmlns:a16="http://schemas.microsoft.com/office/drawing/2014/main" id="{62CE6FF1-B513-4F83-A448-5804DEBACB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4713" y="4816475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0" name="Oval 57">
                <a:extLst>
                  <a:ext uri="{FF2B5EF4-FFF2-40B4-BE49-F238E27FC236}">
                    <a16:creationId xmlns:a16="http://schemas.microsoft.com/office/drawing/2014/main" id="{F4FDB576-622A-4B0B-BD89-415C1D04C6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4713" y="3662363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1" name="Oval 58">
                <a:extLst>
                  <a:ext uri="{FF2B5EF4-FFF2-40B4-BE49-F238E27FC236}">
                    <a16:creationId xmlns:a16="http://schemas.microsoft.com/office/drawing/2014/main" id="{52A53DF1-2A1A-4846-8A31-E0089C26CA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46788" y="4689475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2" name="Oval 59">
                <a:extLst>
                  <a:ext uri="{FF2B5EF4-FFF2-40B4-BE49-F238E27FC236}">
                    <a16:creationId xmlns:a16="http://schemas.microsoft.com/office/drawing/2014/main" id="{50BA20B6-E17E-4546-90E1-F434D31FFB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83313" y="3859213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3" name="Oval 60">
                <a:extLst>
                  <a:ext uri="{FF2B5EF4-FFF2-40B4-BE49-F238E27FC236}">
                    <a16:creationId xmlns:a16="http://schemas.microsoft.com/office/drawing/2014/main" id="{3562C442-35CC-4676-859E-180203513A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11913" y="487045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4" name="Oval 61">
                <a:extLst>
                  <a:ext uri="{FF2B5EF4-FFF2-40B4-BE49-F238E27FC236}">
                    <a16:creationId xmlns:a16="http://schemas.microsoft.com/office/drawing/2014/main" id="{AB526711-EC24-46B7-A69B-518D059452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9301" y="4910138"/>
                <a:ext cx="90488" cy="93662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5" name="Oval 62">
                <a:extLst>
                  <a:ext uri="{FF2B5EF4-FFF2-40B4-BE49-F238E27FC236}">
                    <a16:creationId xmlns:a16="http://schemas.microsoft.com/office/drawing/2014/main" id="{7505D80E-FEB3-4AF4-AF1B-4956C866CC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9301" y="4730750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6" name="Oval 63">
                <a:extLst>
                  <a:ext uri="{FF2B5EF4-FFF2-40B4-BE49-F238E27FC236}">
                    <a16:creationId xmlns:a16="http://schemas.microsoft.com/office/drawing/2014/main" id="{D752E080-28D2-4571-A1D6-90AAD6F75C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9301" y="4503738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7" name="Oval 64">
                <a:extLst>
                  <a:ext uri="{FF2B5EF4-FFF2-40B4-BE49-F238E27FC236}">
                    <a16:creationId xmlns:a16="http://schemas.microsoft.com/office/drawing/2014/main" id="{562CAF09-B585-4AFC-80A2-FF747190E9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72338" y="4832350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" name="Oval 65">
                <a:extLst>
                  <a:ext uri="{FF2B5EF4-FFF2-40B4-BE49-F238E27FC236}">
                    <a16:creationId xmlns:a16="http://schemas.microsoft.com/office/drawing/2014/main" id="{5EBFD967-4A45-4337-8EFE-95675664CB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26313" y="3332163"/>
                <a:ext cx="93663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" name="Oval 66">
                <a:extLst>
                  <a:ext uri="{FF2B5EF4-FFF2-40B4-BE49-F238E27FC236}">
                    <a16:creationId xmlns:a16="http://schemas.microsoft.com/office/drawing/2014/main" id="{869A6154-3629-4C3F-B8F5-E07F370FD6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88238" y="4900613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0" name="Oval 67">
                <a:extLst>
                  <a:ext uri="{FF2B5EF4-FFF2-40B4-BE49-F238E27FC236}">
                    <a16:creationId xmlns:a16="http://schemas.microsoft.com/office/drawing/2014/main" id="{661B23CE-C7E3-4CFF-B93E-D4CF3826EC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4613" y="4941888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1" name="Oval 68">
                <a:extLst>
                  <a:ext uri="{FF2B5EF4-FFF2-40B4-BE49-F238E27FC236}">
                    <a16:creationId xmlns:a16="http://schemas.microsoft.com/office/drawing/2014/main" id="{1A4244B2-77B8-426D-A8DA-D82EC67384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85101" y="4222750"/>
                <a:ext cx="92075" cy="93662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" name="Oval 69">
                <a:extLst>
                  <a:ext uri="{FF2B5EF4-FFF2-40B4-BE49-F238E27FC236}">
                    <a16:creationId xmlns:a16="http://schemas.microsoft.com/office/drawing/2014/main" id="{1DD46A3F-78B9-4216-8532-005B92B3F5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08913" y="4854575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3" name="Oval 70">
                <a:extLst>
                  <a:ext uri="{FF2B5EF4-FFF2-40B4-BE49-F238E27FC236}">
                    <a16:creationId xmlns:a16="http://schemas.microsoft.com/office/drawing/2014/main" id="{516E7DF4-6B43-4084-BA69-7C95FA9C22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99401" y="487045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" name="Oval 71">
                <a:extLst>
                  <a:ext uri="{FF2B5EF4-FFF2-40B4-BE49-F238E27FC236}">
                    <a16:creationId xmlns:a16="http://schemas.microsoft.com/office/drawing/2014/main" id="{F7673E3E-B71A-4DE3-A822-1C13103586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2301" y="4878388"/>
                <a:ext cx="92075" cy="90487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5" name="Oval 72">
                <a:extLst>
                  <a:ext uri="{FF2B5EF4-FFF2-40B4-BE49-F238E27FC236}">
                    <a16:creationId xmlns:a16="http://schemas.microsoft.com/office/drawing/2014/main" id="{B45FDBDC-1F5D-4D22-82E0-DC3E2857F7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85176" y="4949825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" name="Oval 73">
                <a:extLst>
                  <a:ext uri="{FF2B5EF4-FFF2-40B4-BE49-F238E27FC236}">
                    <a16:creationId xmlns:a16="http://schemas.microsoft.com/office/drawing/2014/main" id="{E68F0D98-842C-4F8C-B019-2594203DB2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72488" y="4227513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" name="Oval 74">
                <a:extLst>
                  <a:ext uri="{FF2B5EF4-FFF2-40B4-BE49-F238E27FC236}">
                    <a16:creationId xmlns:a16="http://schemas.microsoft.com/office/drawing/2014/main" id="{988556C0-FBA3-49E7-94D3-4506D9C86C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2038" y="4213225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" name="Oval 75">
                <a:extLst>
                  <a:ext uri="{FF2B5EF4-FFF2-40B4-BE49-F238E27FC236}">
                    <a16:creationId xmlns:a16="http://schemas.microsoft.com/office/drawing/2014/main" id="{CBEB2E8E-476D-4B13-B4C7-791596D4FB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39213" y="4940300"/>
                <a:ext cx="90488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" name="Oval 76">
                <a:extLst>
                  <a:ext uri="{FF2B5EF4-FFF2-40B4-BE49-F238E27FC236}">
                    <a16:creationId xmlns:a16="http://schemas.microsoft.com/office/drawing/2014/main" id="{D4E1DEB0-EA38-45E7-AC5C-B4D614BA78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58288" y="4267200"/>
                <a:ext cx="92075" cy="92075"/>
              </a:xfrm>
              <a:prstGeom prst="ellipse">
                <a:avLst/>
              </a:prstGeom>
              <a:solidFill>
                <a:srgbClr val="A6A6A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" name="Line 77">
                <a:extLst>
                  <a:ext uri="{FF2B5EF4-FFF2-40B4-BE49-F238E27FC236}">
                    <a16:creationId xmlns:a16="http://schemas.microsoft.com/office/drawing/2014/main" id="{F108C4A9-9622-47CF-8F2F-2EA7DE05EA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1576" y="4121150"/>
                <a:ext cx="5561013" cy="595312"/>
              </a:xfrm>
              <a:prstGeom prst="line">
                <a:avLst/>
              </a:prstGeom>
              <a:noFill/>
              <a:ln w="33338" cap="flat">
                <a:solidFill>
                  <a:srgbClr val="D4495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" name="Oval 78">
                <a:extLst>
                  <a:ext uri="{FF2B5EF4-FFF2-40B4-BE49-F238E27FC236}">
                    <a16:creationId xmlns:a16="http://schemas.microsoft.com/office/drawing/2014/main" id="{669C31A1-81EC-4A1D-8D0A-E05B91B583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45511" y="4748213"/>
                <a:ext cx="90488" cy="9207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" name="Rectangle 79">
                <a:extLst>
                  <a:ext uri="{FF2B5EF4-FFF2-40B4-BE49-F238E27FC236}">
                    <a16:creationId xmlns:a16="http://schemas.microsoft.com/office/drawing/2014/main" id="{3D27757B-6760-4266-BA09-0608AFB378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9513" y="835025"/>
                <a:ext cx="5561013" cy="4175125"/>
              </a:xfrm>
              <a:prstGeom prst="rect">
                <a:avLst/>
              </a:prstGeom>
              <a:noFill/>
              <a:ln w="15875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" name="Line 80">
                <a:extLst>
                  <a:ext uri="{FF2B5EF4-FFF2-40B4-BE49-F238E27FC236}">
                    <a16:creationId xmlns:a16="http://schemas.microsoft.com/office/drawing/2014/main" id="{B7A8D920-B7C8-47BE-8E01-7CF327ED8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9513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" name="Line 81">
                <a:extLst>
                  <a:ext uri="{FF2B5EF4-FFF2-40B4-BE49-F238E27FC236}">
                    <a16:creationId xmlns:a16="http://schemas.microsoft.com/office/drawing/2014/main" id="{181B8E5E-8376-475D-A606-4C6DD5D0A1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40263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" name="Line 82">
                <a:extLst>
                  <a:ext uri="{FF2B5EF4-FFF2-40B4-BE49-F238E27FC236}">
                    <a16:creationId xmlns:a16="http://schemas.microsoft.com/office/drawing/2014/main" id="{F3801362-CCF6-408B-8F91-45FCC4DCA4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45138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6" name="Line 83">
                <a:extLst>
                  <a:ext uri="{FF2B5EF4-FFF2-40B4-BE49-F238E27FC236}">
                    <a16:creationId xmlns:a16="http://schemas.microsoft.com/office/drawing/2014/main" id="{2780B873-13D6-412B-8085-6BAFA42FA2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65888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7" name="Line 84">
                <a:extLst>
                  <a:ext uri="{FF2B5EF4-FFF2-40B4-BE49-F238E27FC236}">
                    <a16:creationId xmlns:a16="http://schemas.microsoft.com/office/drawing/2014/main" id="{DE8383E1-9211-4492-88FD-4C6EE143AD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86638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8" name="Line 85">
                <a:extLst>
                  <a:ext uri="{FF2B5EF4-FFF2-40B4-BE49-F238E27FC236}">
                    <a16:creationId xmlns:a16="http://schemas.microsoft.com/office/drawing/2014/main" id="{A8A671DC-A172-47EE-BCD1-F468DB36B9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89926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9" name="Line 86">
                <a:extLst>
                  <a:ext uri="{FF2B5EF4-FFF2-40B4-BE49-F238E27FC236}">
                    <a16:creationId xmlns:a16="http://schemas.microsoft.com/office/drawing/2014/main" id="{98125F85-83AC-40D8-91B7-CBEF239909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12263" y="5010150"/>
                <a:ext cx="0" cy="104775"/>
              </a:xfrm>
              <a:prstGeom prst="line">
                <a:avLst/>
              </a:prstGeom>
              <a:noFill/>
              <a:ln w="1587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" name="Rectangle 87">
                <a:extLst>
                  <a:ext uri="{FF2B5EF4-FFF2-40B4-BE49-F238E27FC236}">
                    <a16:creationId xmlns:a16="http://schemas.microsoft.com/office/drawing/2014/main" id="{819206C9-6571-4AC0-B726-0EFFFD8862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9663" y="5132388"/>
                <a:ext cx="3127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1" name="Rectangle 88">
                <a:extLst>
                  <a:ext uri="{FF2B5EF4-FFF2-40B4-BE49-F238E27FC236}">
                    <a16:creationId xmlns:a16="http://schemas.microsoft.com/office/drawing/2014/main" id="{CBA2C84E-799D-4EA8-91CC-0741918D98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97376" y="5132388"/>
                <a:ext cx="711200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2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2" name="Rectangle 89">
                <a:extLst>
                  <a:ext uri="{FF2B5EF4-FFF2-40B4-BE49-F238E27FC236}">
                    <a16:creationId xmlns:a16="http://schemas.microsoft.com/office/drawing/2014/main" id="{7B00DCDE-CE67-49F4-97A6-53D5824493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0663" y="5132388"/>
                <a:ext cx="711200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4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3" name="Rectangle 90">
                <a:extLst>
                  <a:ext uri="{FF2B5EF4-FFF2-40B4-BE49-F238E27FC236}">
                    <a16:creationId xmlns:a16="http://schemas.microsoft.com/office/drawing/2014/main" id="{8CADD2E6-75E4-4BCD-BBC8-81FD04413D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23001" y="5132388"/>
                <a:ext cx="711200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6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4" name="Rectangle 91">
                <a:extLst>
                  <a:ext uri="{FF2B5EF4-FFF2-40B4-BE49-F238E27FC236}">
                    <a16:creationId xmlns:a16="http://schemas.microsoft.com/office/drawing/2014/main" id="{1AD12433-5F1F-4D70-BD81-FE6C54DECC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3751" y="5132388"/>
                <a:ext cx="711200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8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5" name="Rectangle 92">
                <a:extLst>
                  <a:ext uri="{FF2B5EF4-FFF2-40B4-BE49-F238E27FC236}">
                    <a16:creationId xmlns:a16="http://schemas.microsoft.com/office/drawing/2014/main" id="{F039DF1E-574B-4910-B4AC-0210F333AA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77188" y="5132388"/>
                <a:ext cx="8334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0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6" name="Rectangle 93">
                <a:extLst>
                  <a:ext uri="{FF2B5EF4-FFF2-40B4-BE49-F238E27FC236}">
                    <a16:creationId xmlns:a16="http://schemas.microsoft.com/office/drawing/2014/main" id="{CCCD693E-529F-4FDF-8DA0-BB1F945ED8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29676" y="5132388"/>
                <a:ext cx="833438" cy="401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20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8" name="Rectangle 95">
                <a:extLst>
                  <a:ext uri="{FF2B5EF4-FFF2-40B4-BE49-F238E27FC236}">
                    <a16:creationId xmlns:a16="http://schemas.microsoft.com/office/drawing/2014/main" id="{6A7B2147-11FC-4544-8791-5F0D8359CB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66017" y="5584731"/>
                <a:ext cx="2839624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Total dose of steroid </a:t>
                </a:r>
                <a:r>
                  <a:rPr kumimoji="0" lang="en-US" altLang="ja-JP" sz="1700" dirty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(mg)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A77707B1-37B6-4FDF-A67D-909EA5C7DFF9}"/>
                </a:ext>
              </a:extLst>
            </p:cNvPr>
            <p:cNvSpPr txBox="1"/>
            <p:nvPr/>
          </p:nvSpPr>
          <p:spPr>
            <a:xfrm>
              <a:off x="5966779" y="2268319"/>
              <a:ext cx="103425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</a:t>
              </a:r>
              <a:r>
                <a:rPr kumimoji="1" lang="en-US" altLang="ja-JP" baseline="30000" dirty="0"/>
                <a:t>2</a:t>
              </a:r>
              <a:r>
                <a:rPr kumimoji="1" lang="en-US" altLang="ja-JP" dirty="0"/>
                <a:t>=0.03</a:t>
              </a:r>
            </a:p>
            <a:p>
              <a:r>
                <a:rPr lang="en-US" altLang="ja-JP" dirty="0"/>
                <a:t>P=0.19</a:t>
              </a:r>
              <a:endParaRPr kumimoji="1" lang="ja-JP" altLang="en-US" dirty="0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6DFE157-863F-4BC9-99CE-8C1427DB5300}"/>
              </a:ext>
            </a:extLst>
          </p:cNvPr>
          <p:cNvSpPr txBox="1"/>
          <p:nvPr/>
        </p:nvSpPr>
        <p:spPr>
          <a:xfrm>
            <a:off x="1525710" y="5906304"/>
            <a:ext cx="94423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Supplemental figure. Correlation between preoperative steroid dose and LCR values.</a:t>
            </a:r>
            <a:endParaRPr kumimoji="1" lang="ja-JP" altLang="en-US" sz="16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3863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37</Words>
  <Application>Microsoft Office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メイリオ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池 勇樹</dc:creator>
  <cp:lastModifiedBy>小池 勇樹</cp:lastModifiedBy>
  <cp:revision>5</cp:revision>
  <dcterms:created xsi:type="dcterms:W3CDTF">2026-04-18T12:54:20Z</dcterms:created>
  <dcterms:modified xsi:type="dcterms:W3CDTF">2026-04-21T00:49:21Z</dcterms:modified>
</cp:coreProperties>
</file>